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fr-FR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DD010F1-BC05-4471-A396-313C11EC39DE}" v="9" dt="2024-06-13T13:10:33.08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102" y="75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lare McFadden" userId="ab624a3e-7a31-49c4-89db-b1d90fd58891" providerId="ADAL" clId="{CDD010F1-BC05-4471-A396-313C11EC39DE}"/>
    <pc:docChg chg="custSel addSld modSld">
      <pc:chgData name="Clare McFadden" userId="ab624a3e-7a31-49c4-89db-b1d90fd58891" providerId="ADAL" clId="{CDD010F1-BC05-4471-A396-313C11EC39DE}" dt="2024-06-13T13:10:38.329" v="41" actId="1076"/>
      <pc:docMkLst>
        <pc:docMk/>
      </pc:docMkLst>
      <pc:sldChg chg="addSp delSp modSp mod">
        <pc:chgData name="Clare McFadden" userId="ab624a3e-7a31-49c4-89db-b1d90fd58891" providerId="ADAL" clId="{CDD010F1-BC05-4471-A396-313C11EC39DE}" dt="2024-06-13T13:10:38.329" v="41" actId="1076"/>
        <pc:sldMkLst>
          <pc:docMk/>
          <pc:sldMk cId="0" sldId="257"/>
        </pc:sldMkLst>
        <pc:spChg chg="add mod">
          <ac:chgData name="Clare McFadden" userId="ab624a3e-7a31-49c4-89db-b1d90fd58891" providerId="ADAL" clId="{CDD010F1-BC05-4471-A396-313C11EC39DE}" dt="2024-06-13T13:10:38.329" v="41" actId="1076"/>
          <ac:spMkLst>
            <pc:docMk/>
            <pc:sldMk cId="0" sldId="257"/>
            <ac:spMk id="2" creationId="{9CC98E7A-B572-4731-6877-7832BBB709E3}"/>
          </ac:spMkLst>
        </pc:spChg>
        <pc:spChg chg="add del mod">
          <ac:chgData name="Clare McFadden" userId="ab624a3e-7a31-49c4-89db-b1d90fd58891" providerId="ADAL" clId="{CDD010F1-BC05-4471-A396-313C11EC39DE}" dt="2024-06-13T12:19:36.693" v="1"/>
          <ac:spMkLst>
            <pc:docMk/>
            <pc:sldMk cId="0" sldId="257"/>
            <ac:spMk id="2" creationId="{BE368A45-49DD-8621-8DDB-DA6E2BA5F67D}"/>
          </ac:spMkLst>
        </pc:spChg>
        <pc:spChg chg="add mod">
          <ac:chgData name="Clare McFadden" userId="ab624a3e-7a31-49c4-89db-b1d90fd58891" providerId="ADAL" clId="{CDD010F1-BC05-4471-A396-313C11EC39DE}" dt="2024-06-13T12:20:38.659" v="17" actId="20577"/>
          <ac:spMkLst>
            <pc:docMk/>
            <pc:sldMk cId="0" sldId="257"/>
            <ac:spMk id="3" creationId="{710726D5-B34B-CEBF-7BD4-C89E4BE3FAC8}"/>
          </ac:spMkLst>
        </pc:spChg>
        <pc:picChg chg="mod">
          <ac:chgData name="Clare McFadden" userId="ab624a3e-7a31-49c4-89db-b1d90fd58891" providerId="ADAL" clId="{CDD010F1-BC05-4471-A396-313C11EC39DE}" dt="2024-06-13T12:19:57.833" v="8" actId="1076"/>
          <ac:picMkLst>
            <pc:docMk/>
            <pc:sldMk cId="0" sldId="257"/>
            <ac:picMk id="2051" creationId="{00000000-0000-0000-0000-000000000000}"/>
          </ac:picMkLst>
        </pc:picChg>
        <pc:cxnChg chg="mod">
          <ac:chgData name="Clare McFadden" userId="ab624a3e-7a31-49c4-89db-b1d90fd58891" providerId="ADAL" clId="{CDD010F1-BC05-4471-A396-313C11EC39DE}" dt="2024-06-13T12:19:57.833" v="8" actId="1076"/>
          <ac:cxnSpMkLst>
            <pc:docMk/>
            <pc:sldMk cId="0" sldId="257"/>
            <ac:cxnSpMk id="4" creationId="{00000000-0000-0000-0000-000000000000}"/>
          </ac:cxnSpMkLst>
        </pc:cxnChg>
      </pc:sldChg>
      <pc:sldChg chg="addSp delSp modSp new mod modClrScheme chgLayout">
        <pc:chgData name="Clare McFadden" userId="ab624a3e-7a31-49c4-89db-b1d90fd58891" providerId="ADAL" clId="{CDD010F1-BC05-4471-A396-313C11EC39DE}" dt="2024-06-13T12:21:00.734" v="26" actId="20577"/>
        <pc:sldMkLst>
          <pc:docMk/>
          <pc:sldMk cId="3114423857" sldId="258"/>
        </pc:sldMkLst>
        <pc:spChg chg="del">
          <ac:chgData name="Clare McFadden" userId="ab624a3e-7a31-49c4-89db-b1d90fd58891" providerId="ADAL" clId="{CDD010F1-BC05-4471-A396-313C11EC39DE}" dt="2024-06-13T12:20:29.353" v="13" actId="700"/>
          <ac:spMkLst>
            <pc:docMk/>
            <pc:sldMk cId="3114423857" sldId="258"/>
            <ac:spMk id="2" creationId="{7E67241E-7255-59F8-3CFC-9F7144864F5E}"/>
          </ac:spMkLst>
        </pc:spChg>
        <pc:spChg chg="del">
          <ac:chgData name="Clare McFadden" userId="ab624a3e-7a31-49c4-89db-b1d90fd58891" providerId="ADAL" clId="{CDD010F1-BC05-4471-A396-313C11EC39DE}" dt="2024-06-13T12:20:29.353" v="13" actId="700"/>
          <ac:spMkLst>
            <pc:docMk/>
            <pc:sldMk cId="3114423857" sldId="258"/>
            <ac:spMk id="3" creationId="{728596EC-3A12-24E0-34DF-C73FCAA741BA}"/>
          </ac:spMkLst>
        </pc:spChg>
        <pc:spChg chg="add mod">
          <ac:chgData name="Clare McFadden" userId="ab624a3e-7a31-49c4-89db-b1d90fd58891" providerId="ADAL" clId="{CDD010F1-BC05-4471-A396-313C11EC39DE}" dt="2024-06-13T12:21:00.734" v="26" actId="20577"/>
          <ac:spMkLst>
            <pc:docMk/>
            <pc:sldMk cId="3114423857" sldId="258"/>
            <ac:spMk id="6" creationId="{B5517236-D347-ECD9-CC62-CB57F8C8CCF4}"/>
          </ac:spMkLst>
        </pc:spChg>
        <pc:picChg chg="add mod">
          <ac:chgData name="Clare McFadden" userId="ab624a3e-7a31-49c4-89db-b1d90fd58891" providerId="ADAL" clId="{CDD010F1-BC05-4471-A396-313C11EC39DE}" dt="2024-06-13T12:20:32.364" v="15" actId="1076"/>
          <ac:picMkLst>
            <pc:docMk/>
            <pc:sldMk cId="3114423857" sldId="258"/>
            <ac:picMk id="5" creationId="{FB9D4480-0882-4B46-8E38-DB14ADF9B866}"/>
          </ac:picMkLst>
        </pc:picChg>
      </pc:sldChg>
      <pc:sldChg chg="addSp delSp modSp new mod">
        <pc:chgData name="Clare McFadden" userId="ab624a3e-7a31-49c4-89db-b1d90fd58891" providerId="ADAL" clId="{CDD010F1-BC05-4471-A396-313C11EC39DE}" dt="2024-06-13T12:21:45.198" v="37" actId="165"/>
        <pc:sldMkLst>
          <pc:docMk/>
          <pc:sldMk cId="1207972277" sldId="259"/>
        </pc:sldMkLst>
        <pc:spChg chg="add mod topLvl">
          <ac:chgData name="Clare McFadden" userId="ab624a3e-7a31-49c4-89db-b1d90fd58891" providerId="ADAL" clId="{CDD010F1-BC05-4471-A396-313C11EC39DE}" dt="2024-06-13T12:21:45.198" v="37" actId="165"/>
          <ac:spMkLst>
            <pc:docMk/>
            <pc:sldMk cId="1207972277" sldId="259"/>
            <ac:spMk id="3" creationId="{D21766F9-BBE0-6756-0303-CB6EFAC66D11}"/>
          </ac:spMkLst>
        </pc:spChg>
        <pc:spChg chg="add mod">
          <ac:chgData name="Clare McFadden" userId="ab624a3e-7a31-49c4-89db-b1d90fd58891" providerId="ADAL" clId="{CDD010F1-BC05-4471-A396-313C11EC39DE}" dt="2024-06-13T12:21:41.129" v="36" actId="1076"/>
          <ac:spMkLst>
            <pc:docMk/>
            <pc:sldMk cId="1207972277" sldId="259"/>
            <ac:spMk id="5" creationId="{3DDAB22E-EFDF-F53C-1FD4-16DB53FAE232}"/>
          </ac:spMkLst>
        </pc:spChg>
        <pc:grpChg chg="add del mod">
          <ac:chgData name="Clare McFadden" userId="ab624a3e-7a31-49c4-89db-b1d90fd58891" providerId="ADAL" clId="{CDD010F1-BC05-4471-A396-313C11EC39DE}" dt="2024-06-13T12:21:45.198" v="37" actId="165"/>
          <ac:grpSpMkLst>
            <pc:docMk/>
            <pc:sldMk cId="1207972277" sldId="259"/>
            <ac:grpSpMk id="4" creationId="{07895527-4F25-463B-1FC4-BD6584F91693}"/>
          </ac:grpSpMkLst>
        </pc:grpChg>
        <pc:picChg chg="add mod topLvl">
          <ac:chgData name="Clare McFadden" userId="ab624a3e-7a31-49c4-89db-b1d90fd58891" providerId="ADAL" clId="{CDD010F1-BC05-4471-A396-313C11EC39DE}" dt="2024-06-13T12:21:45.198" v="37" actId="165"/>
          <ac:picMkLst>
            <pc:docMk/>
            <pc:sldMk cId="1207972277" sldId="259"/>
            <ac:picMk id="2" creationId="{106D3DE3-8D3C-7585-99AB-00468A002954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583FCB-69F9-476E-B472-2A5AF06A472C}" type="datetimeFigureOut">
              <a:rPr lang="fr-FR"/>
              <a:pPr>
                <a:defRPr/>
              </a:pPr>
              <a:t>13/06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8B812E-7B87-419C-B977-B29577FC00C2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0998A7-45C1-4052-A215-94D510212F95}" type="datetimeFigureOut">
              <a:rPr lang="fr-FR"/>
              <a:pPr>
                <a:defRPr/>
              </a:pPr>
              <a:t>13/06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9AADBE-03D2-4BDE-BDFE-008BF92A03B6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332F37-D14F-4F9A-9120-6094961A6460}" type="datetimeFigureOut">
              <a:rPr lang="fr-FR"/>
              <a:pPr>
                <a:defRPr/>
              </a:pPr>
              <a:t>13/06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C9A957-F93B-4AAA-874B-AAF3239EB130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813DC1-2FE7-458F-ADDB-3A6511637A21}" type="datetimeFigureOut">
              <a:rPr lang="fr-FR"/>
              <a:pPr>
                <a:defRPr/>
              </a:pPr>
              <a:t>13/06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71BE68-D245-4A17-A2C8-1AB7486AE706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E0C2CF-CA02-40EB-A009-06D98166B105}" type="datetimeFigureOut">
              <a:rPr lang="fr-FR"/>
              <a:pPr>
                <a:defRPr/>
              </a:pPr>
              <a:t>13/06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506C1B-44F7-4765-A4CE-9E04EB02C539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DCB139-3A5B-492B-ADB4-64CE2BDD6DE8}" type="datetimeFigureOut">
              <a:rPr lang="fr-FR"/>
              <a:pPr>
                <a:defRPr/>
              </a:pPr>
              <a:t>13/06/2024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A42F9E-DE64-42A3-83A0-D2385C972049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570060-7C04-4EFA-BBF7-487C8A6878F4}" type="datetimeFigureOut">
              <a:rPr lang="fr-FR"/>
              <a:pPr>
                <a:defRPr/>
              </a:pPr>
              <a:t>13/06/2024</a:t>
            </a:fld>
            <a:endParaRPr lang="fr-FR"/>
          </a:p>
        </p:txBody>
      </p:sp>
      <p:sp>
        <p:nvSpPr>
          <p:cNvPr id="8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2DB1C3-CF93-4423-9072-CCD5B907E29F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747198-8670-4DCE-A099-14BEB509A0D2}" type="datetimeFigureOut">
              <a:rPr lang="fr-FR"/>
              <a:pPr>
                <a:defRPr/>
              </a:pPr>
              <a:t>13/06/2024</a:t>
            </a:fld>
            <a:endParaRPr lang="fr-FR"/>
          </a:p>
        </p:txBody>
      </p:sp>
      <p:sp>
        <p:nvSpPr>
          <p:cNvPr id="4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958DB8-0388-4F85-BFAD-560821C34183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37D9E8-E3E8-4D41-8E70-9C74D10469D0}" type="datetimeFigureOut">
              <a:rPr lang="fr-FR"/>
              <a:pPr>
                <a:defRPr/>
              </a:pPr>
              <a:t>13/06/2024</a:t>
            </a:fld>
            <a:endParaRPr lang="fr-FR"/>
          </a:p>
        </p:txBody>
      </p:sp>
      <p:sp>
        <p:nvSpPr>
          <p:cNvPr id="3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77032A-A89F-4107-BD6A-26870531D7F4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BFBD03-0EF7-494B-8664-C4B83BE24861}" type="datetimeFigureOut">
              <a:rPr lang="fr-FR"/>
              <a:pPr>
                <a:defRPr/>
              </a:pPr>
              <a:t>13/06/2024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E370F3-2F38-4B7B-AA30-B037EA8C5C58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0ECB1F-CF55-4FA0-AC1C-F063B0A0B69E}" type="datetimeFigureOut">
              <a:rPr lang="fr-FR"/>
              <a:pPr>
                <a:defRPr/>
              </a:pPr>
              <a:t>13/06/2024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BBC070-9627-41F2-ADC5-6ADD95D6A815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 style du titre</a:t>
            </a:r>
          </a:p>
        </p:txBody>
      </p:sp>
      <p:sp>
        <p:nvSpPr>
          <p:cNvPr id="1027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8E86502B-C247-43B8-8A08-CD9163A1DEF8}" type="datetimeFigureOut">
              <a:rPr lang="fr-FR"/>
              <a:pPr>
                <a:defRPr/>
              </a:pPr>
              <a:t>13/06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3C70A5C7-7902-4E18-93C1-4EE695FAB347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Image 3" descr="F:\p30 maha.jpg"/>
          <p:cNvPicPr>
            <a:picLocks noChangeAspect="1" noChangeArrowheads="1"/>
          </p:cNvPicPr>
          <p:nvPr/>
        </p:nvPicPr>
        <p:blipFill>
          <a:blip r:embed="rId2" cstate="print">
            <a:grayscl/>
            <a:lum bright="-10000" contrast="40000"/>
          </a:blip>
          <a:srcRect/>
          <a:stretch>
            <a:fillRect/>
          </a:stretch>
        </p:blipFill>
        <p:spPr bwMode="auto">
          <a:xfrm rot="21459478">
            <a:off x="1357648" y="1221435"/>
            <a:ext cx="4832350" cy="4895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4" name="Connecteur droit avec flèche 3"/>
          <p:cNvCxnSpPr/>
          <p:nvPr/>
        </p:nvCxnSpPr>
        <p:spPr>
          <a:xfrm>
            <a:off x="3707905" y="980727"/>
            <a:ext cx="0" cy="648072"/>
          </a:xfrm>
          <a:prstGeom prst="straightConnector1">
            <a:avLst/>
          </a:prstGeom>
          <a:ln w="3810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710726D5-B34B-CEBF-7BD4-C89E4BE3FAC8}"/>
              </a:ext>
            </a:extLst>
          </p:cNvPr>
          <p:cNvSpPr txBox="1"/>
          <p:nvPr/>
        </p:nvSpPr>
        <p:spPr>
          <a:xfrm>
            <a:off x="1511661" y="241614"/>
            <a:ext cx="43924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chemeClr val="tx2"/>
                </a:solidFill>
              </a:rPr>
              <a:t>Original blot for Figure 4A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CC98E7A-B572-4731-6877-7832BBB709E3}"/>
              </a:ext>
            </a:extLst>
          </p:cNvPr>
          <p:cNvSpPr txBox="1"/>
          <p:nvPr/>
        </p:nvSpPr>
        <p:spPr>
          <a:xfrm>
            <a:off x="827584" y="6231681"/>
            <a:ext cx="7488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l the lines in the original blot correspond to the same extract. </a:t>
            </a:r>
            <a:endParaRPr lang="en-GB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B9D4480-0882-4B46-8E38-DB14ADF9B8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7704" y="1340768"/>
            <a:ext cx="5769499" cy="517180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5517236-D347-ECD9-CC62-CB57F8C8CCF4}"/>
              </a:ext>
            </a:extLst>
          </p:cNvPr>
          <p:cNvSpPr txBox="1"/>
          <p:nvPr/>
        </p:nvSpPr>
        <p:spPr>
          <a:xfrm>
            <a:off x="2051720" y="326925"/>
            <a:ext cx="43924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chemeClr val="tx2"/>
                </a:solidFill>
              </a:rPr>
              <a:t>Original gel for Figure 4B </a:t>
            </a:r>
          </a:p>
        </p:txBody>
      </p:sp>
    </p:spTree>
    <p:extLst>
      <p:ext uri="{BB962C8B-B14F-4D97-AF65-F5344CB8AC3E}">
        <p14:creationId xmlns:p14="http://schemas.microsoft.com/office/powerpoint/2010/main" val="31144238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6">
            <a:extLst>
              <a:ext uri="{FF2B5EF4-FFF2-40B4-BE49-F238E27FC236}">
                <a16:creationId xmlns:a16="http://schemas.microsoft.com/office/drawing/2014/main" id="{106D3DE3-8D3C-7585-99AB-00468A00295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lum contrast="-24000"/>
          </a:blip>
          <a:srcRect/>
          <a:stretch>
            <a:fillRect/>
          </a:stretch>
        </p:blipFill>
        <p:spPr bwMode="auto">
          <a:xfrm>
            <a:off x="2555776" y="980728"/>
            <a:ext cx="4521538" cy="517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D21766F9-BBE0-6756-0303-CB6EFAC66D11}"/>
              </a:ext>
            </a:extLst>
          </p:cNvPr>
          <p:cNvSpPr/>
          <p:nvPr/>
        </p:nvSpPr>
        <p:spPr>
          <a:xfrm>
            <a:off x="5393943" y="2338112"/>
            <a:ext cx="641673" cy="30849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DDAB22E-EFDF-F53C-1FD4-16DB53FAE232}"/>
              </a:ext>
            </a:extLst>
          </p:cNvPr>
          <p:cNvSpPr txBox="1"/>
          <p:nvPr/>
        </p:nvSpPr>
        <p:spPr>
          <a:xfrm>
            <a:off x="2195736" y="295624"/>
            <a:ext cx="43924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chemeClr val="tx2"/>
                </a:solidFill>
              </a:rPr>
              <a:t>Original blot for Figure 4C </a:t>
            </a:r>
          </a:p>
        </p:txBody>
      </p:sp>
    </p:spTree>
    <p:extLst>
      <p:ext uri="{BB962C8B-B14F-4D97-AF65-F5344CB8AC3E}">
        <p14:creationId xmlns:p14="http://schemas.microsoft.com/office/powerpoint/2010/main" val="120797227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On-screen Show (4:3)</PresentationFormat>
  <Paragraphs>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Thème Office</vt:lpstr>
      <vt:lpstr>PowerPoint Presentation</vt:lpstr>
      <vt:lpstr>PowerPoint Presentation</vt:lpstr>
      <vt:lpstr>PowerPoint Presentation</vt:lpstr>
    </vt:vector>
  </TitlesOfParts>
  <Company>ip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labimmuno</dc:creator>
  <cp:lastModifiedBy>Clare McFadden</cp:lastModifiedBy>
  <cp:revision>20</cp:revision>
  <dcterms:created xsi:type="dcterms:W3CDTF">2012-06-25T12:04:53Z</dcterms:created>
  <dcterms:modified xsi:type="dcterms:W3CDTF">2024-06-13T13:10:42Z</dcterms:modified>
</cp:coreProperties>
</file>